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1" d="100"/>
          <a:sy n="81" d="100"/>
        </p:scale>
        <p:origin x="-189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353005-FFBD-654F-BD7A-B2C9025251FE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F0A774-297F-F445-98D4-EDCFB3E6D91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32037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Figure 3A. 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Molecular Transport, Embryonic Development, Organ Development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2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3B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ancer,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Dermatological Diseases and Conditions, Tumor Morphology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3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3C.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Cellular Compromise, Organismal Injury and Abnormalities, Skeletal and Muscular Disorder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4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3D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ellular Movement,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Neurological Diseases, Organismal Injury and Abnormaliti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5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3E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Digestive System Development and Function, Organ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Morphology, Organismal Development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6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baseline="0" smtClean="0">
                <a:latin typeface="Times New Roman" pitchFamily="18" charset="0"/>
                <a:cs typeface="Times New Roman" pitchFamily="18" charset="0"/>
              </a:rPr>
              <a:t>Figure 3F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Ophthalmic Disease, Organismal Injury and Abnormalities, Organ Morphology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7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3910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8962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2482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439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4738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07372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9792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4564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283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04188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65071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2096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833736"/>
            <a:ext cx="8229600" cy="3292428"/>
          </a:xfrm>
        </p:spPr>
        <p:txBody>
          <a:bodyPr anchor="ctr">
            <a:normAutofit/>
          </a:bodyPr>
          <a:lstStyle/>
          <a:p>
            <a:pPr>
              <a:buNone/>
            </a:pP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dirty="0" smtClean="0">
                <a:latin typeface="Times New Roman" pitchFamily="18" charset="0"/>
                <a:cs typeface="Times New Roman" pitchFamily="18" charset="0"/>
              </a:rPr>
              <a:t>File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smtClean="0">
                <a:latin typeface="Times New Roman" pitchFamily="18" charset="0"/>
                <a:cs typeface="Times New Roman" pitchFamily="18" charset="0"/>
              </a:rPr>
              <a:t>17</a:t>
            </a:r>
            <a:r>
              <a:rPr lang="en-US" sz="1800" b="1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IPA Gene Network Analysis.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op gene networks for down-regulated miRNAs (maturation/secretory)and their validated predicted gene target candidates were generated by IPA to show their directed interactions, with 14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-C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and 7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D-F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molecules involved in each network.</a:t>
            </a:r>
            <a:endParaRPr lang="en-US" sz="1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14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1221" y="0"/>
            <a:ext cx="6821557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/>
                <a:cs typeface="Times New Roman"/>
              </a:rPr>
              <a:t>3</a:t>
            </a:r>
            <a:r>
              <a:rPr kumimoji="1" lang="en-US" altLang="zh-CN" b="1" dirty="0" smtClean="0">
                <a:latin typeface="Times New Roman"/>
                <a:cs typeface="Times New Roman"/>
              </a:rPr>
              <a:t>A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140_network_4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3000" y="0"/>
            <a:ext cx="685800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3B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140_network_5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194" y="0"/>
            <a:ext cx="6753612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3C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7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3517" y="0"/>
            <a:ext cx="6716965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3D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70_network_2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2834" y="0"/>
            <a:ext cx="8118331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3E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own_miRNA_up_mRNA_70_network_6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7967" y="0"/>
            <a:ext cx="6728066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3F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58</Words>
  <Application>Microsoft Macintosh PowerPoint</Application>
  <PresentationFormat>全屏显示(4:3)</PresentationFormat>
  <Paragraphs>19</Paragraphs>
  <Slides>7</Slides>
  <Notes>6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feng Yin</dc:creator>
  <cp:lastModifiedBy>Kaifeng Yin</cp:lastModifiedBy>
  <cp:revision>22</cp:revision>
  <dcterms:created xsi:type="dcterms:W3CDTF">2014-06-26T21:41:25Z</dcterms:created>
  <dcterms:modified xsi:type="dcterms:W3CDTF">2014-07-24T23:16:40Z</dcterms:modified>
</cp:coreProperties>
</file>